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697A62-106F-4501-BD7B-7589D2BDC83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42F058-3A21-4AF8-862C-8DB17FEB7D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02993F-4840-4700-9D0E-3C8CB71DB37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8615FE-447C-4900-8A3F-992B6AF5CE2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231113-BF17-4736-9AB0-909B196AD3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668270-35D6-4D6E-9A86-AC5324D188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0FDDC3-2EF0-42BE-973E-265EA3AC2C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DBE1A7-4651-44E2-A077-CF903CEA22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5B7328-D943-4ECD-98D9-41F6FAC88C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E4DEE0-B31A-4925-908E-A0005797DF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59F372-9C78-4ED2-B947-ED45FFD7AE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32C491-1D82-406E-87C8-F56B63E596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8857B7F-682E-40A3-9AFD-3809FF12AA6C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676520" y="2200320"/>
          <a:ext cx="6705360" cy="2592360"/>
        </p:xfrm>
        <a:graphic>
          <a:graphicData uri="http://schemas.openxmlformats.org/drawingml/2006/table">
            <a:tbl>
              <a:tblPr/>
              <a:tblGrid>
                <a:gridCol w="1360440"/>
                <a:gridCol w="5344920"/>
              </a:tblGrid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RE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mphiregulin (schwannoma-derived growth factor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C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reakpoint cluster reg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D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D24 molecul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DH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nl-NL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dherin 1, type 1, E-cadherin (epithelial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5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DN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audin 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DN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audin 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FNB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phrin-B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GF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ibroblast growth factor 9 (glia-activating factor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U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usion (involved in t(12;16) in malignant liposarcoma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APK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itogen-activated protein kinase 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V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ephroblastoma overexpressed gen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PAP2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hosphatidic acid phosphatase type 2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PAR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roxisome proliferator-activated receptor gamm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PP2R3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otein phosphatase 2 (formerly 2A), regulatory subunit B'', bet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9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PP3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otein phosphatase 3 (formerly 2B), catalytic subunit, alpha isofor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AB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AB25, member RAS oncogene family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72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OX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RY (sex determining region Y)-box 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360"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BE2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biquitin-conjugating enzyme E2M (UBC12 homolog, yeast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40" marR="68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itle 1"/>
          <p:cNvSpPr/>
          <p:nvPr/>
        </p:nvSpPr>
        <p:spPr>
          <a:xfrm>
            <a:off x="0" y="-36360"/>
            <a:ext cx="2830680" cy="688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3 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06T09:35:09Z</dcterms:created>
  <dc:creator>Admin</dc:creator>
  <dc:description/>
  <dc:language>en-US</dc:language>
  <cp:lastModifiedBy>Nome utente</cp:lastModifiedBy>
  <dcterms:modified xsi:type="dcterms:W3CDTF">2011-05-23T13:09:55Z</dcterms:modified>
  <cp:revision>256</cp:revision>
  <dc:subject/>
  <dc:title>Diapositiva 1</dc:title>
</cp:coreProperties>
</file>